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8EF285F-B8CE-4365-8B5B-3D86CBE3702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4389CC3-1307-4E4C-B91D-265A8E59754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69F639D-A422-433C-807C-3AFE6BB958C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7C4C756-5C3D-4B93-B6EF-43635C568E5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C4A91F3-74B2-4EA1-A363-67E32952005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EE14E80-9705-4A20-9C20-EC8445116FC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D03B104-7802-457B-B272-67BB11DF0DB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A27CF2C-97C4-47A7-B8B5-65E0FB7F90E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FEE9BDA-D8B4-4CE8-A616-5314D572A30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5F5AA8-F656-4887-AC5E-FFE800D6242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E7BD31-8BF6-4601-96AE-C3BBDCCF5AD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3AC7DC-778C-4F72-83B9-967085BFC69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1EE76AC-2967-47D9-8EB1-E29FD0168F6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89000" y="1781280"/>
            <a:ext cx="6669000" cy="4492440"/>
          </a:xfrm>
          <a:prstGeom prst="rect">
            <a:avLst/>
          </a:prstGeom>
          <a:ln w="0">
            <a:noFill/>
          </a:ln>
        </p:spPr>
      </p:pic>
      <p:sp>
        <p:nvSpPr>
          <p:cNvPr id="42" name=""/>
          <p:cNvSpPr/>
          <p:nvPr/>
        </p:nvSpPr>
        <p:spPr>
          <a:xfrm>
            <a:off x="404640" y="6753240"/>
            <a:ext cx="612144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1.</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presentation of mouse testis transcripts according to SAGE analysis. Transcripts are ordered by decreasing representation, measured as PPM (Parts per Million). The red line indicates detection threshold for xenoarray analysis (1700 transcripts).</a:t>
            </a:r>
            <a:endParaRPr b="0" lang="en-US" sz="1200" spc="-1" strike="noStrike">
              <a:solidFill>
                <a:srgbClr val="000000"/>
              </a:solidFill>
              <a:latin typeface="Arial"/>
            </a:endParaRPr>
          </a:p>
        </p:txBody>
      </p:sp>
      <p:sp>
        <p:nvSpPr>
          <p:cNvPr id="43" name=""/>
          <p:cNvSpPr/>
          <p:nvPr/>
        </p:nvSpPr>
        <p:spPr>
          <a:xfrm flipV="1">
            <a:off x="1925640" y="1981080"/>
            <a:ext cx="0" cy="352440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2833920" y="5908680"/>
            <a:ext cx="2199960" cy="3682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Transcript number</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1-30T13:44:08Z</dcterms:created>
  <dc:creator>emedico</dc:creator>
  <dc:description/>
  <dc:language>en-US</dc:language>
  <cp:lastModifiedBy>emedico</cp:lastModifiedBy>
  <dcterms:modified xsi:type="dcterms:W3CDTF">2008-05-29T13:03:58Z</dcterms:modified>
  <cp:revision>8</cp:revision>
  <dc:subject/>
  <dc:title>Slide 1</dc:title>
</cp:coreProperties>
</file>